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A50CB-580C-4847-ACBC-0C1668DA4B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65232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9120" y="6389640"/>
            <a:ext cx="65232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6E0E9-2F2E-490C-9F3C-AD07D1ECE7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17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9120" y="638964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1720" y="638964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6876B-38BA-418D-B6B3-03350B54D3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24840" y="284652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30560" y="284652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9120" y="638964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24840" y="638964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30560" y="6389640"/>
            <a:ext cx="210024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A2A23A-4541-4E02-AC7B-239026415B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9120" y="2846520"/>
            <a:ext cx="6523200" cy="678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624"/>
              </a:spcBef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9DB46-8737-4145-9A2E-50B578A390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65232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319D4-4433-48BD-8667-23FFFE484B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318312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1720" y="2846520"/>
            <a:ext cx="318312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0CDB1-262C-4903-B95B-53DF2F7655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E3232-7B69-430F-A17C-3CB532B2A7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9120" y="569520"/>
            <a:ext cx="6523200" cy="957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624"/>
              </a:spcBef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3DD89-509F-4309-95F6-A09405EF60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1720" y="2846520"/>
            <a:ext cx="318312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9120" y="638964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77238-514D-4D50-82F6-2E48A221D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318312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17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1720" y="638964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32CEE-C72F-410F-BCE1-36297EE4DB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91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1720" y="2846520"/>
            <a:ext cx="318312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9120" y="6389640"/>
            <a:ext cx="6523200" cy="323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624"/>
              </a:spcBef>
              <a:buNone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3FFB2-E049-474B-A6B7-3BFF45F517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9120" y="569520"/>
            <a:ext cx="6523200" cy="2065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9120" y="2846520"/>
            <a:ext cx="6523200" cy="67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4112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1" marL="42372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2" marL="708120" indent="-1414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3" marL="99216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4" marL="127476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5" marL="127476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  <a:p>
            <a:pPr lvl="6" marL="1274760" indent="-14112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566640"/>
                <a:tab algn="l" pos="1133640"/>
                <a:tab algn="l" pos="1700280"/>
                <a:tab algn="l" pos="2266920"/>
                <a:tab algn="l" pos="2833560"/>
                <a:tab algn="l" pos="3400560"/>
                <a:tab algn="l" pos="3967200"/>
                <a:tab algn="l" pos="4533840"/>
                <a:tab algn="l" pos="5100480"/>
                <a:tab algn="l" pos="5667480"/>
                <a:tab algn="l" pos="6234120"/>
                <a:tab algn="l" pos="6800760"/>
                <a:tab algn="l" pos="7367760"/>
                <a:tab algn="l" pos="7934400"/>
                <a:tab algn="l" pos="8501040"/>
                <a:tab algn="l" pos="9067680"/>
                <a:tab algn="l" pos="9634680"/>
                <a:tab algn="l" pos="10201320"/>
                <a:tab algn="l" pos="1076796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1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8760" y="9909000"/>
            <a:ext cx="170172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7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7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05240" y="9909000"/>
            <a:ext cx="255096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340240" y="9909000"/>
            <a:ext cx="170208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7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7C4F9F-84E3-4DAF-94AB-C8416BD138EC}" type="slidenum">
              <a:rPr b="0" lang="ko-KR" sz="7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그림 2" descr=""/>
          <p:cNvPicPr/>
          <p:nvPr/>
        </p:nvPicPr>
        <p:blipFill>
          <a:blip r:embed="rId1"/>
          <a:stretch/>
        </p:blipFill>
        <p:spPr>
          <a:xfrm>
            <a:off x="0" y="507960"/>
            <a:ext cx="7561440" cy="6051600"/>
          </a:xfrm>
          <a:prstGeom prst="rect">
            <a:avLst/>
          </a:prstGeom>
          <a:ln w="0">
            <a:noFill/>
          </a:ln>
        </p:spPr>
      </p:pic>
      <p:sp>
        <p:nvSpPr>
          <p:cNvPr id="42" name="TextBox 1"/>
          <p:cNvSpPr/>
          <p:nvPr/>
        </p:nvSpPr>
        <p:spPr>
          <a:xfrm>
            <a:off x="271080" y="338040"/>
            <a:ext cx="7019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stogram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f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rticipants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y serum LDL-C level (n=3230)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519480" y="6483240"/>
            <a:ext cx="4608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DL-C level was calculated by Friedewald formula. 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34 (16.53%) participants had LDL-C levels below 70mg/dL.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21T05:03:18Z</dcterms:created>
  <dc:creator>user</dc:creator>
  <dc:description/>
  <dc:language>en-US</dc:language>
  <cp:lastModifiedBy>user</cp:lastModifiedBy>
  <dcterms:modified xsi:type="dcterms:W3CDTF">2022-09-21T05:10:18Z</dcterms:modified>
  <cp:revision>2</cp:revision>
  <dc:subject/>
  <dc:title>PowerPoint 프레젠테이션</dc:title>
</cp:coreProperties>
</file>